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 autoCompressPictures="0" bookmarkIdSeed="2">
  <p:sldMasterIdLst>
    <p:sldMasterId id="2147483660" r:id="rId1"/>
  </p:sldMasterIdLst>
  <p:notesMasterIdLst>
    <p:notesMasterId r:id="rId3"/>
  </p:notesMasterIdLst>
  <p:sldIdLst>
    <p:sldId id="271" r:id="rId2"/>
  </p:sldIdLst>
  <p:sldSz cx="6858000" cy="12192000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408" autoAdjust="0"/>
    <p:restoredTop sz="94660"/>
  </p:normalViewPr>
  <p:slideViewPr>
    <p:cSldViewPr snapToGrid="0">
      <p:cViewPr varScale="1">
        <p:scale>
          <a:sx n="55" d="100"/>
          <a:sy n="55" d="100"/>
        </p:scale>
        <p:origin x="2712" y="62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88620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1588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fld id="{FD8DA6FD-2EBA-4BF6-9DDA-B364D4F79689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1" anchor="ctr"/>
          <a:lstStyle/>
          <a:p>
            <a:endParaRPr lang="he-I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1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388620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1588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fld id="{2C703604-0067-48E4-A4C0-5F034A2E907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102405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755729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709614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005831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0640569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078070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064481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9441511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57266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75598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9028600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3527260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B695E1-599A-47BC-A184-95F804A95903}" type="datetimeFigureOut">
              <a:rPr lang="he-IL" smtClean="0"/>
              <a:t>י"ב/טבת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2EAEBC-7A46-4046-8538-264453565E54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658213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1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r" defTabSz="685800" rtl="1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DA3E8D6A-5E8A-2091-FBD6-218661C844D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13741721"/>
              </p:ext>
            </p:extLst>
          </p:nvPr>
        </p:nvGraphicFramePr>
        <p:xfrm>
          <a:off x="0" y="414917"/>
          <a:ext cx="6731000" cy="6729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6209460" imgH="6208335" progId="Prism8.Document">
                  <p:embed/>
                </p:oleObj>
              </mc:Choice>
              <mc:Fallback>
                <p:oleObj name="Prism 8" r:id="rId2" imgW="6209460" imgH="620833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0" y="414917"/>
                        <a:ext cx="6731000" cy="6729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Subtitle 1">
            <a:extLst>
              <a:ext uri="{FF2B5EF4-FFF2-40B4-BE49-F238E27FC236}">
                <a16:creationId xmlns:a16="http://schemas.microsoft.com/office/drawing/2014/main" id="{16DEC739-648D-10FF-4A0A-BFBFCA5CC2EF}"/>
              </a:ext>
            </a:extLst>
          </p:cNvPr>
          <p:cNvSpPr txBox="1">
            <a:spLocks/>
          </p:cNvSpPr>
          <p:nvPr/>
        </p:nvSpPr>
        <p:spPr>
          <a:xfrm>
            <a:off x="343094" y="7601293"/>
            <a:ext cx="6171812" cy="1050111"/>
          </a:xfrm>
          <a:prstGeom prst="rect">
            <a:avLst/>
          </a:prstGeom>
        </p:spPr>
        <p:txBody>
          <a:bodyPr/>
          <a:lstStyle>
            <a:lvl1pPr marL="171450" indent="-171450" algn="r" defTabSz="685800" rtl="1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r" defTabSz="685800" rtl="1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l" rtl="0">
              <a:buNone/>
            </a:pPr>
            <a:r>
              <a:rPr lang="en-US" sz="1200" b="1" dirty="0">
                <a:latin typeface="Arial (body)"/>
              </a:rPr>
              <a:t>Figure S7.</a:t>
            </a:r>
            <a:r>
              <a:rPr lang="en-US" sz="1200" dirty="0">
                <a:latin typeface="Arial (body)"/>
              </a:rPr>
              <a:t> Levels of IL-12p70, IL-17A, IL-23, IL-27, MCP-1, IFN-β, IFN-γ, and GM-CSF in supernatants of colon punch biopsies (n=6-8). Representative data of one out of three independent experiments.   p&lt;0.05=∗; p&lt;0.01=∗∗; p&lt;0.001=∗∗∗; p&lt;0.0001=∗∗∗∗.</a:t>
            </a:r>
            <a:endParaRPr lang="en-IL" sz="1200" dirty="0">
              <a:latin typeface="Arial (body)"/>
            </a:endParaRPr>
          </a:p>
        </p:txBody>
      </p:sp>
    </p:spTree>
    <p:extLst>
      <p:ext uri="{BB962C8B-B14F-4D97-AF65-F5344CB8AC3E}">
        <p14:creationId xmlns:p14="http://schemas.microsoft.com/office/powerpoint/2010/main" val="38171197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676</TotalTime>
  <Words>66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Arial (body)</vt:lpstr>
      <vt:lpstr>Calibri</vt:lpstr>
      <vt:lpstr>Calibri Light</vt:lpstr>
      <vt:lpstr>Office Theme</vt:lpstr>
      <vt:lpstr>Prism 8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28.6.2021</dc:title>
  <dc:creator>Hadas Ashkenazi</dc:creator>
  <cp:lastModifiedBy>Or Reuven</cp:lastModifiedBy>
  <cp:revision>212</cp:revision>
  <dcterms:created xsi:type="dcterms:W3CDTF">2021-06-28T09:42:38Z</dcterms:created>
  <dcterms:modified xsi:type="dcterms:W3CDTF">2023-12-24T13:23:11Z</dcterms:modified>
</cp:coreProperties>
</file>